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notesMasterIdLst>
    <p:notesMasterId r:id="rId7"/>
  </p:notesMasterIdLst>
  <p:sldIdLst>
    <p:sldId id="266" r:id="rId2"/>
    <p:sldId id="263" r:id="rId3"/>
    <p:sldId id="267" r:id="rId4"/>
    <p:sldId id="268" r:id="rId5"/>
    <p:sldId id="269" r:id="rId6"/>
  </p:sldIdLst>
  <p:sldSz cx="33623250" cy="385921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154" userDrawn="1">
          <p15:clr>
            <a:srgbClr val="A4A3A4"/>
          </p15:clr>
        </p15:guide>
        <p15:guide id="2" pos="10590" userDrawn="1">
          <p15:clr>
            <a:srgbClr val="A4A3A4"/>
          </p15:clr>
        </p15:guide>
        <p15:guide id="3" pos="2117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DA1CF"/>
    <a:srgbClr val="FF8599"/>
    <a:srgbClr val="FEACE7"/>
    <a:srgbClr val="FECAE0"/>
    <a:srgbClr val="FEBED9"/>
    <a:srgbClr val="FFAFD1"/>
    <a:srgbClr val="FCB2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 autoAdjust="0"/>
    <p:restoredTop sz="90135" autoAdjust="0"/>
  </p:normalViewPr>
  <p:slideViewPr>
    <p:cSldViewPr snapToGrid="0">
      <p:cViewPr varScale="1">
        <p:scale>
          <a:sx n="22" d="100"/>
          <a:sy n="22" d="100"/>
        </p:scale>
        <p:origin x="3736" y="312"/>
      </p:cViewPr>
      <p:guideLst>
        <p:guide orient="horz" pos="12154"/>
        <p:guide pos="10590"/>
        <p:guide pos="211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A30741-067E-4EB1-B3E4-E5174B576879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084388" y="1143000"/>
            <a:ext cx="2689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450EA-FA87-4F4F-9218-B89F1DA0CA8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728342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F450EA-FA87-4F4F-9218-B89F1DA0CA8B}" type="slidenum">
              <a:rPr lang="ru-RU" smtClean="0"/>
              <a:pPr/>
              <a:t>2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370553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21744" y="6315890"/>
            <a:ext cx="28579763" cy="13435777"/>
          </a:xfrm>
        </p:spPr>
        <p:txBody>
          <a:bodyPr anchor="b"/>
          <a:lstStyle>
            <a:lvl1pPr algn="ctr">
              <a:defRPr sz="22063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202906" y="20269802"/>
            <a:ext cx="25217438" cy="9317494"/>
          </a:xfrm>
        </p:spPr>
        <p:txBody>
          <a:bodyPr/>
          <a:lstStyle>
            <a:lvl1pPr marL="0" indent="0" algn="ctr">
              <a:buNone/>
              <a:defRPr sz="8825"/>
            </a:lvl1pPr>
            <a:lvl2pPr marL="1681170" indent="0" algn="ctr">
              <a:buNone/>
              <a:defRPr sz="7354"/>
            </a:lvl2pPr>
            <a:lvl3pPr marL="3362340" indent="0" algn="ctr">
              <a:buNone/>
              <a:defRPr sz="6619"/>
            </a:lvl3pPr>
            <a:lvl4pPr marL="5043510" indent="0" algn="ctr">
              <a:buNone/>
              <a:defRPr sz="5883"/>
            </a:lvl4pPr>
            <a:lvl5pPr marL="6724680" indent="0" algn="ctr">
              <a:buNone/>
              <a:defRPr sz="5883"/>
            </a:lvl5pPr>
            <a:lvl6pPr marL="8405851" indent="0" algn="ctr">
              <a:buNone/>
              <a:defRPr sz="5883"/>
            </a:lvl6pPr>
            <a:lvl7pPr marL="10087021" indent="0" algn="ctr">
              <a:buNone/>
              <a:defRPr sz="5883"/>
            </a:lvl7pPr>
            <a:lvl8pPr marL="11768191" indent="0" algn="ctr">
              <a:buNone/>
              <a:defRPr sz="5883"/>
            </a:lvl8pPr>
            <a:lvl9pPr marL="13449361" indent="0" algn="ctr">
              <a:buNone/>
              <a:defRPr sz="5883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7691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5276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4061640" y="2054673"/>
            <a:ext cx="7250013" cy="32705042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11600" y="2054673"/>
            <a:ext cx="21329749" cy="32705042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06463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09795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94088" y="9621243"/>
            <a:ext cx="29000053" cy="16053249"/>
          </a:xfrm>
        </p:spPr>
        <p:txBody>
          <a:bodyPr anchor="b"/>
          <a:lstStyle>
            <a:lvl1pPr>
              <a:defRPr sz="22063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94088" y="25826361"/>
            <a:ext cx="29000053" cy="8442025"/>
          </a:xfrm>
        </p:spPr>
        <p:txBody>
          <a:bodyPr/>
          <a:lstStyle>
            <a:lvl1pPr marL="0" indent="0">
              <a:buNone/>
              <a:defRPr sz="8825">
                <a:solidFill>
                  <a:schemeClr val="tx1"/>
                </a:solidFill>
              </a:defRPr>
            </a:lvl1pPr>
            <a:lvl2pPr marL="1681170" indent="0">
              <a:buNone/>
              <a:defRPr sz="7354">
                <a:solidFill>
                  <a:schemeClr val="tx1">
                    <a:tint val="75000"/>
                  </a:schemeClr>
                </a:solidFill>
              </a:defRPr>
            </a:lvl2pPr>
            <a:lvl3pPr marL="3362340" indent="0">
              <a:buNone/>
              <a:defRPr sz="6619">
                <a:solidFill>
                  <a:schemeClr val="tx1">
                    <a:tint val="75000"/>
                  </a:schemeClr>
                </a:solidFill>
              </a:defRPr>
            </a:lvl3pPr>
            <a:lvl4pPr marL="5043510" indent="0">
              <a:buNone/>
              <a:defRPr sz="5883">
                <a:solidFill>
                  <a:schemeClr val="tx1">
                    <a:tint val="75000"/>
                  </a:schemeClr>
                </a:solidFill>
              </a:defRPr>
            </a:lvl4pPr>
            <a:lvl5pPr marL="6724680" indent="0">
              <a:buNone/>
              <a:defRPr sz="5883">
                <a:solidFill>
                  <a:schemeClr val="tx1">
                    <a:tint val="75000"/>
                  </a:schemeClr>
                </a:solidFill>
              </a:defRPr>
            </a:lvl5pPr>
            <a:lvl6pPr marL="8405851" indent="0">
              <a:buNone/>
              <a:defRPr sz="5883">
                <a:solidFill>
                  <a:schemeClr val="tx1">
                    <a:tint val="75000"/>
                  </a:schemeClr>
                </a:solidFill>
              </a:defRPr>
            </a:lvl6pPr>
            <a:lvl7pPr marL="10087021" indent="0">
              <a:buNone/>
              <a:defRPr sz="5883">
                <a:solidFill>
                  <a:schemeClr val="tx1">
                    <a:tint val="75000"/>
                  </a:schemeClr>
                </a:solidFill>
              </a:defRPr>
            </a:lvl7pPr>
            <a:lvl8pPr marL="11768191" indent="0">
              <a:buNone/>
              <a:defRPr sz="5883">
                <a:solidFill>
                  <a:schemeClr val="tx1">
                    <a:tint val="75000"/>
                  </a:schemeClr>
                </a:solidFill>
              </a:defRPr>
            </a:lvl8pPr>
            <a:lvl9pPr marL="13449361" indent="0">
              <a:buNone/>
              <a:defRPr sz="58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52938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11599" y="10273367"/>
            <a:ext cx="14289881" cy="2448634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021770" y="10273367"/>
            <a:ext cx="14289881" cy="2448634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54864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15978" y="2054682"/>
            <a:ext cx="29000053" cy="7459360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15981" y="9460434"/>
            <a:ext cx="14224209" cy="4636412"/>
          </a:xfrm>
        </p:spPr>
        <p:txBody>
          <a:bodyPr anchor="b"/>
          <a:lstStyle>
            <a:lvl1pPr marL="0" indent="0">
              <a:buNone/>
              <a:defRPr sz="8825" b="1"/>
            </a:lvl1pPr>
            <a:lvl2pPr marL="1681170" indent="0">
              <a:buNone/>
              <a:defRPr sz="7354" b="1"/>
            </a:lvl2pPr>
            <a:lvl3pPr marL="3362340" indent="0">
              <a:buNone/>
              <a:defRPr sz="6619" b="1"/>
            </a:lvl3pPr>
            <a:lvl4pPr marL="5043510" indent="0">
              <a:buNone/>
              <a:defRPr sz="5883" b="1"/>
            </a:lvl4pPr>
            <a:lvl5pPr marL="6724680" indent="0">
              <a:buNone/>
              <a:defRPr sz="5883" b="1"/>
            </a:lvl5pPr>
            <a:lvl6pPr marL="8405851" indent="0">
              <a:buNone/>
              <a:defRPr sz="5883" b="1"/>
            </a:lvl6pPr>
            <a:lvl7pPr marL="10087021" indent="0">
              <a:buNone/>
              <a:defRPr sz="5883" b="1"/>
            </a:lvl7pPr>
            <a:lvl8pPr marL="11768191" indent="0">
              <a:buNone/>
              <a:defRPr sz="5883" b="1"/>
            </a:lvl8pPr>
            <a:lvl9pPr marL="13449361" indent="0">
              <a:buNone/>
              <a:defRPr sz="588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5981" y="14096845"/>
            <a:ext cx="14224209" cy="20734337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7021772" y="9460434"/>
            <a:ext cx="14294261" cy="4636412"/>
          </a:xfrm>
        </p:spPr>
        <p:txBody>
          <a:bodyPr anchor="b"/>
          <a:lstStyle>
            <a:lvl1pPr marL="0" indent="0">
              <a:buNone/>
              <a:defRPr sz="8825" b="1"/>
            </a:lvl1pPr>
            <a:lvl2pPr marL="1681170" indent="0">
              <a:buNone/>
              <a:defRPr sz="7354" b="1"/>
            </a:lvl2pPr>
            <a:lvl3pPr marL="3362340" indent="0">
              <a:buNone/>
              <a:defRPr sz="6619" b="1"/>
            </a:lvl3pPr>
            <a:lvl4pPr marL="5043510" indent="0">
              <a:buNone/>
              <a:defRPr sz="5883" b="1"/>
            </a:lvl4pPr>
            <a:lvl5pPr marL="6724680" indent="0">
              <a:buNone/>
              <a:defRPr sz="5883" b="1"/>
            </a:lvl5pPr>
            <a:lvl6pPr marL="8405851" indent="0">
              <a:buNone/>
              <a:defRPr sz="5883" b="1"/>
            </a:lvl6pPr>
            <a:lvl7pPr marL="10087021" indent="0">
              <a:buNone/>
              <a:defRPr sz="5883" b="1"/>
            </a:lvl7pPr>
            <a:lvl8pPr marL="11768191" indent="0">
              <a:buNone/>
              <a:defRPr sz="5883" b="1"/>
            </a:lvl8pPr>
            <a:lvl9pPr marL="13449361" indent="0">
              <a:buNone/>
              <a:defRPr sz="588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7021772" y="14096845"/>
            <a:ext cx="14294261" cy="20734337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35911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14182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94015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15978" y="2572808"/>
            <a:ext cx="10844373" cy="9004829"/>
          </a:xfrm>
        </p:spPr>
        <p:txBody>
          <a:bodyPr anchor="b"/>
          <a:lstStyle>
            <a:lvl1pPr>
              <a:defRPr sz="117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294261" y="5556560"/>
            <a:ext cx="17021770" cy="27425422"/>
          </a:xfrm>
        </p:spPr>
        <p:txBody>
          <a:bodyPr/>
          <a:lstStyle>
            <a:lvl1pPr>
              <a:defRPr sz="11767"/>
            </a:lvl1pPr>
            <a:lvl2pPr>
              <a:defRPr sz="10296"/>
            </a:lvl2pPr>
            <a:lvl3pPr>
              <a:defRPr sz="8825"/>
            </a:lvl3pPr>
            <a:lvl4pPr>
              <a:defRPr sz="7354"/>
            </a:lvl4pPr>
            <a:lvl5pPr>
              <a:defRPr sz="7354"/>
            </a:lvl5pPr>
            <a:lvl6pPr>
              <a:defRPr sz="7354"/>
            </a:lvl6pPr>
            <a:lvl7pPr>
              <a:defRPr sz="7354"/>
            </a:lvl7pPr>
            <a:lvl8pPr>
              <a:defRPr sz="7354"/>
            </a:lvl8pPr>
            <a:lvl9pPr>
              <a:defRPr sz="7354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15978" y="11577637"/>
            <a:ext cx="10844373" cy="21449006"/>
          </a:xfrm>
        </p:spPr>
        <p:txBody>
          <a:bodyPr/>
          <a:lstStyle>
            <a:lvl1pPr marL="0" indent="0">
              <a:buNone/>
              <a:defRPr sz="5883"/>
            </a:lvl1pPr>
            <a:lvl2pPr marL="1681170" indent="0">
              <a:buNone/>
              <a:defRPr sz="5148"/>
            </a:lvl2pPr>
            <a:lvl3pPr marL="3362340" indent="0">
              <a:buNone/>
              <a:defRPr sz="4413"/>
            </a:lvl3pPr>
            <a:lvl4pPr marL="5043510" indent="0">
              <a:buNone/>
              <a:defRPr sz="3677"/>
            </a:lvl4pPr>
            <a:lvl5pPr marL="6724680" indent="0">
              <a:buNone/>
              <a:defRPr sz="3677"/>
            </a:lvl5pPr>
            <a:lvl6pPr marL="8405851" indent="0">
              <a:buNone/>
              <a:defRPr sz="3677"/>
            </a:lvl6pPr>
            <a:lvl7pPr marL="10087021" indent="0">
              <a:buNone/>
              <a:defRPr sz="3677"/>
            </a:lvl7pPr>
            <a:lvl8pPr marL="11768191" indent="0">
              <a:buNone/>
              <a:defRPr sz="3677"/>
            </a:lvl8pPr>
            <a:lvl9pPr marL="13449361" indent="0">
              <a:buNone/>
              <a:defRPr sz="3677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26801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15978" y="2572808"/>
            <a:ext cx="10844373" cy="9004829"/>
          </a:xfrm>
        </p:spPr>
        <p:txBody>
          <a:bodyPr anchor="b"/>
          <a:lstStyle>
            <a:lvl1pPr>
              <a:defRPr sz="117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4294261" y="5556560"/>
            <a:ext cx="17021770" cy="27425422"/>
          </a:xfrm>
        </p:spPr>
        <p:txBody>
          <a:bodyPr anchor="t"/>
          <a:lstStyle>
            <a:lvl1pPr marL="0" indent="0">
              <a:buNone/>
              <a:defRPr sz="11767"/>
            </a:lvl1pPr>
            <a:lvl2pPr marL="1681170" indent="0">
              <a:buNone/>
              <a:defRPr sz="10296"/>
            </a:lvl2pPr>
            <a:lvl3pPr marL="3362340" indent="0">
              <a:buNone/>
              <a:defRPr sz="8825"/>
            </a:lvl3pPr>
            <a:lvl4pPr marL="5043510" indent="0">
              <a:buNone/>
              <a:defRPr sz="7354"/>
            </a:lvl4pPr>
            <a:lvl5pPr marL="6724680" indent="0">
              <a:buNone/>
              <a:defRPr sz="7354"/>
            </a:lvl5pPr>
            <a:lvl6pPr marL="8405851" indent="0">
              <a:buNone/>
              <a:defRPr sz="7354"/>
            </a:lvl6pPr>
            <a:lvl7pPr marL="10087021" indent="0">
              <a:buNone/>
              <a:defRPr sz="7354"/>
            </a:lvl7pPr>
            <a:lvl8pPr marL="11768191" indent="0">
              <a:buNone/>
              <a:defRPr sz="7354"/>
            </a:lvl8pPr>
            <a:lvl9pPr marL="13449361" indent="0">
              <a:buNone/>
              <a:defRPr sz="7354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15978" y="11577637"/>
            <a:ext cx="10844373" cy="21449006"/>
          </a:xfrm>
        </p:spPr>
        <p:txBody>
          <a:bodyPr/>
          <a:lstStyle>
            <a:lvl1pPr marL="0" indent="0">
              <a:buNone/>
              <a:defRPr sz="5883"/>
            </a:lvl1pPr>
            <a:lvl2pPr marL="1681170" indent="0">
              <a:buNone/>
              <a:defRPr sz="5148"/>
            </a:lvl2pPr>
            <a:lvl3pPr marL="3362340" indent="0">
              <a:buNone/>
              <a:defRPr sz="4413"/>
            </a:lvl3pPr>
            <a:lvl4pPr marL="5043510" indent="0">
              <a:buNone/>
              <a:defRPr sz="3677"/>
            </a:lvl4pPr>
            <a:lvl5pPr marL="6724680" indent="0">
              <a:buNone/>
              <a:defRPr sz="3677"/>
            </a:lvl5pPr>
            <a:lvl6pPr marL="8405851" indent="0">
              <a:buNone/>
              <a:defRPr sz="3677"/>
            </a:lvl6pPr>
            <a:lvl7pPr marL="10087021" indent="0">
              <a:buNone/>
              <a:defRPr sz="3677"/>
            </a:lvl7pPr>
            <a:lvl8pPr marL="11768191" indent="0">
              <a:buNone/>
              <a:defRPr sz="3677"/>
            </a:lvl8pPr>
            <a:lvl9pPr marL="13449361" indent="0">
              <a:buNone/>
              <a:defRPr sz="3677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24076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311599" y="2054682"/>
            <a:ext cx="29000053" cy="74593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11599" y="10273367"/>
            <a:ext cx="29000053" cy="244863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311599" y="35769191"/>
            <a:ext cx="7565231" cy="20546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41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28FA98-780D-4F9E-BAED-772DC64315B7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137702" y="35769191"/>
            <a:ext cx="11347847" cy="20546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41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3746420" y="35769191"/>
            <a:ext cx="7565231" cy="20546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41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B0786-1BE7-4FE6-9722-954B56D1A39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38200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3362340" rtl="0" eaLnBrk="1" latinLnBrk="0" hangingPunct="1">
        <a:lnSpc>
          <a:spcPct val="90000"/>
        </a:lnSpc>
        <a:spcBef>
          <a:spcPct val="0"/>
        </a:spcBef>
        <a:buNone/>
        <a:defRPr sz="161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40585" indent="-840585" algn="l" defTabSz="3362340" rtl="0" eaLnBrk="1" latinLnBrk="0" hangingPunct="1">
        <a:lnSpc>
          <a:spcPct val="90000"/>
        </a:lnSpc>
        <a:spcBef>
          <a:spcPts val="3677"/>
        </a:spcBef>
        <a:buFont typeface="Arial" panose="020B0604020202020204" pitchFamily="34" charset="0"/>
        <a:buChar char="•"/>
        <a:defRPr sz="10296" kern="1200">
          <a:solidFill>
            <a:schemeClr val="tx1"/>
          </a:solidFill>
          <a:latin typeface="+mn-lt"/>
          <a:ea typeface="+mn-ea"/>
          <a:cs typeface="+mn-cs"/>
        </a:defRPr>
      </a:lvl1pPr>
      <a:lvl2pPr marL="2521755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8825" kern="1200">
          <a:solidFill>
            <a:schemeClr val="tx1"/>
          </a:solidFill>
          <a:latin typeface="+mn-lt"/>
          <a:ea typeface="+mn-ea"/>
          <a:cs typeface="+mn-cs"/>
        </a:defRPr>
      </a:lvl2pPr>
      <a:lvl3pPr marL="4202925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7354" kern="1200">
          <a:solidFill>
            <a:schemeClr val="tx1"/>
          </a:solidFill>
          <a:latin typeface="+mn-lt"/>
          <a:ea typeface="+mn-ea"/>
          <a:cs typeface="+mn-cs"/>
        </a:defRPr>
      </a:lvl3pPr>
      <a:lvl4pPr marL="5884095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6619" kern="1200">
          <a:solidFill>
            <a:schemeClr val="tx1"/>
          </a:solidFill>
          <a:latin typeface="+mn-lt"/>
          <a:ea typeface="+mn-ea"/>
          <a:cs typeface="+mn-cs"/>
        </a:defRPr>
      </a:lvl4pPr>
      <a:lvl5pPr marL="7565266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6619" kern="1200">
          <a:solidFill>
            <a:schemeClr val="tx1"/>
          </a:solidFill>
          <a:latin typeface="+mn-lt"/>
          <a:ea typeface="+mn-ea"/>
          <a:cs typeface="+mn-cs"/>
        </a:defRPr>
      </a:lvl5pPr>
      <a:lvl6pPr marL="9246436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6619" kern="1200">
          <a:solidFill>
            <a:schemeClr val="tx1"/>
          </a:solidFill>
          <a:latin typeface="+mn-lt"/>
          <a:ea typeface="+mn-ea"/>
          <a:cs typeface="+mn-cs"/>
        </a:defRPr>
      </a:lvl6pPr>
      <a:lvl7pPr marL="10927606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6619" kern="1200">
          <a:solidFill>
            <a:schemeClr val="tx1"/>
          </a:solidFill>
          <a:latin typeface="+mn-lt"/>
          <a:ea typeface="+mn-ea"/>
          <a:cs typeface="+mn-cs"/>
        </a:defRPr>
      </a:lvl7pPr>
      <a:lvl8pPr marL="12608776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6619" kern="1200">
          <a:solidFill>
            <a:schemeClr val="tx1"/>
          </a:solidFill>
          <a:latin typeface="+mn-lt"/>
          <a:ea typeface="+mn-ea"/>
          <a:cs typeface="+mn-cs"/>
        </a:defRPr>
      </a:lvl8pPr>
      <a:lvl9pPr marL="14289946" indent="-840585" algn="l" defTabSz="3362340" rtl="0" eaLnBrk="1" latinLnBrk="0" hangingPunct="1">
        <a:lnSpc>
          <a:spcPct val="90000"/>
        </a:lnSpc>
        <a:spcBef>
          <a:spcPts val="1839"/>
        </a:spcBef>
        <a:buFont typeface="Arial" panose="020B0604020202020204" pitchFamily="34" charset="0"/>
        <a:buChar char="•"/>
        <a:defRPr sz="661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1pPr>
      <a:lvl2pPr marL="1681170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2pPr>
      <a:lvl3pPr marL="3362340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3pPr>
      <a:lvl4pPr marL="5043510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4pPr>
      <a:lvl5pPr marL="6724680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5pPr>
      <a:lvl6pPr marL="8405851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6pPr>
      <a:lvl7pPr marL="10087021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7pPr>
      <a:lvl8pPr marL="11768191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8pPr>
      <a:lvl9pPr marL="13449361" algn="l" defTabSz="3362340" rtl="0" eaLnBrk="1" latinLnBrk="0" hangingPunct="1">
        <a:defRPr sz="661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777344"/>
            <a:ext cx="33623250" cy="29238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b="1" dirty="0"/>
              <a:t>Novel </a:t>
            </a:r>
            <a:r>
              <a:rPr lang="en-US" sz="4800" b="1" dirty="0" err="1"/>
              <a:t>porphyrazine</a:t>
            </a:r>
            <a:r>
              <a:rPr lang="en-US" sz="4800" b="1" dirty="0"/>
              <a:t>-based photodynamic anti-cancer therapy induces immunogenic cell death</a:t>
            </a:r>
          </a:p>
          <a:p>
            <a:pPr algn="ctr"/>
            <a:endParaRPr lang="en-US" sz="4000" dirty="0"/>
          </a:p>
          <a:p>
            <a:pPr algn="ctr"/>
            <a:r>
              <a:rPr lang="en-US" sz="4800" dirty="0"/>
              <a:t>Victoria D. </a:t>
            </a:r>
            <a:r>
              <a:rPr lang="en-US" sz="4800" dirty="0" err="1"/>
              <a:t>Turubanova</a:t>
            </a:r>
            <a:r>
              <a:rPr lang="en-US" sz="4800" dirty="0"/>
              <a:t>, Tatiana A. </a:t>
            </a:r>
            <a:r>
              <a:rPr lang="en-US" sz="4800" dirty="0" err="1"/>
              <a:t>Mishchenko</a:t>
            </a:r>
            <a:r>
              <a:rPr lang="en-US" sz="4800" dirty="0"/>
              <a:t>, Irina V. </a:t>
            </a:r>
            <a:r>
              <a:rPr lang="en-US" sz="4800" dirty="0" err="1"/>
              <a:t>Balalaeva</a:t>
            </a:r>
            <a:r>
              <a:rPr lang="en-US" sz="4800" dirty="0"/>
              <a:t>, </a:t>
            </a:r>
            <a:r>
              <a:rPr lang="en-US" sz="4800" dirty="0" err="1"/>
              <a:t>Iuliia</a:t>
            </a:r>
            <a:r>
              <a:rPr lang="en-US" sz="4800" dirty="0"/>
              <a:t> </a:t>
            </a:r>
            <a:r>
              <a:rPr lang="en-US" sz="4800" dirty="0" err="1"/>
              <a:t>Efimova</a:t>
            </a:r>
            <a:r>
              <a:rPr lang="en-US" sz="4800" dirty="0"/>
              <a:t>, Nina N. </a:t>
            </a:r>
            <a:r>
              <a:rPr lang="en-US" sz="4800" dirty="0" err="1"/>
              <a:t>Peskova</a:t>
            </a:r>
            <a:r>
              <a:rPr lang="en-US" sz="4800" dirty="0"/>
              <a:t>, Larisa G. </a:t>
            </a:r>
            <a:r>
              <a:rPr lang="en-US" sz="4800" dirty="0" err="1"/>
              <a:t>Klapshina</a:t>
            </a:r>
            <a:r>
              <a:rPr lang="en-US" sz="4800" dirty="0"/>
              <a:t>, Svetlana A. </a:t>
            </a:r>
            <a:r>
              <a:rPr lang="en-US" sz="4800" dirty="0" err="1"/>
              <a:t>Lermontova</a:t>
            </a:r>
            <a:r>
              <a:rPr lang="en-US" sz="4800" dirty="0"/>
              <a:t>, Claus </a:t>
            </a:r>
            <a:r>
              <a:rPr lang="en-US" sz="4800" dirty="0" err="1"/>
              <a:t>Bachert</a:t>
            </a:r>
            <a:r>
              <a:rPr lang="en-US" sz="4800" dirty="0"/>
              <a:t>, Olga Krysko, Maria V. </a:t>
            </a:r>
            <a:r>
              <a:rPr lang="en-US" sz="4800" dirty="0" err="1"/>
              <a:t>Vedunova</a:t>
            </a:r>
            <a:r>
              <a:rPr lang="en-US" sz="4800" dirty="0"/>
              <a:t>, Dmitri V. Krysko</a:t>
            </a:r>
          </a:p>
        </p:txBody>
      </p:sp>
      <p:pic>
        <p:nvPicPr>
          <p:cNvPr id="13" name="Рисунок 12">
            <a:extLst>
              <a:ext uri="{FF2B5EF4-FFF2-40B4-BE49-F238E27FC236}">
                <a16:creationId xmlns:a16="http://schemas.microsoft.com/office/drawing/2014/main" id="{23539B44-B7EC-41D2-B36A-9180413BFB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5582" y="4677611"/>
            <a:ext cx="23503908" cy="3350612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4120147-4AB2-4375-92F8-86BE390F9AAC}"/>
              </a:ext>
            </a:extLst>
          </p:cNvPr>
          <p:cNvSpPr txBox="1"/>
          <p:nvPr/>
        </p:nvSpPr>
        <p:spPr>
          <a:xfrm>
            <a:off x="2036845" y="4348602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A</a:t>
            </a:r>
            <a:endParaRPr lang="ru-RU" sz="96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C468E7D-84F4-457D-B318-BBA795DE3138}"/>
              </a:ext>
            </a:extLst>
          </p:cNvPr>
          <p:cNvSpPr txBox="1"/>
          <p:nvPr/>
        </p:nvSpPr>
        <p:spPr>
          <a:xfrm>
            <a:off x="14124571" y="4348602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B</a:t>
            </a:r>
            <a:endParaRPr lang="ru-RU" sz="96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EA0E3A0-EBBA-4227-9565-F9B32DD7C209}"/>
              </a:ext>
            </a:extLst>
          </p:cNvPr>
          <p:cNvSpPr txBox="1"/>
          <p:nvPr/>
        </p:nvSpPr>
        <p:spPr>
          <a:xfrm>
            <a:off x="2044867" y="14703787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C</a:t>
            </a:r>
            <a:endParaRPr lang="ru-RU" sz="96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2DD5BC5-CAA9-43A7-9686-46A28AB1F2EC}"/>
              </a:ext>
            </a:extLst>
          </p:cNvPr>
          <p:cNvSpPr txBox="1"/>
          <p:nvPr/>
        </p:nvSpPr>
        <p:spPr>
          <a:xfrm>
            <a:off x="14132593" y="14703787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D</a:t>
            </a:r>
            <a:endParaRPr lang="ru-RU" sz="96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CB4F42C-81E9-4B30-B641-9839EC42AEA6}"/>
              </a:ext>
            </a:extLst>
          </p:cNvPr>
          <p:cNvSpPr txBox="1"/>
          <p:nvPr/>
        </p:nvSpPr>
        <p:spPr>
          <a:xfrm>
            <a:off x="2101015" y="25058970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E</a:t>
            </a:r>
            <a:endParaRPr lang="ru-RU" sz="96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A092912-C832-4E08-A174-0E1639B13A88}"/>
              </a:ext>
            </a:extLst>
          </p:cNvPr>
          <p:cNvSpPr txBox="1"/>
          <p:nvPr/>
        </p:nvSpPr>
        <p:spPr>
          <a:xfrm>
            <a:off x="14188741" y="25058970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F</a:t>
            </a:r>
            <a:endParaRPr lang="ru-RU" sz="96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5760401-D944-464C-B575-185E497E653D}"/>
              </a:ext>
            </a:extLst>
          </p:cNvPr>
          <p:cNvSpPr txBox="1"/>
          <p:nvPr/>
        </p:nvSpPr>
        <p:spPr>
          <a:xfrm flipH="1">
            <a:off x="24384000" y="37404751"/>
            <a:ext cx="92392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/>
              <a:t>Supplementary Figure 1.</a:t>
            </a:r>
            <a:endParaRPr lang="ru-RU" sz="6600" b="1" dirty="0"/>
          </a:p>
        </p:txBody>
      </p:sp>
    </p:spTree>
    <p:extLst>
      <p:ext uri="{BB962C8B-B14F-4D97-AF65-F5344CB8AC3E}">
        <p14:creationId xmlns:p14="http://schemas.microsoft.com/office/powerpoint/2010/main" val="1086480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2">
            <a:extLst>
              <a:ext uri="{FF2B5EF4-FFF2-40B4-BE49-F238E27FC236}">
                <a16:creationId xmlns:a16="http://schemas.microsoft.com/office/drawing/2014/main" id="{9B4ACB6F-EC11-44D8-B0D7-5DA3B4E1A54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82757" y="8503282"/>
            <a:ext cx="8598789" cy="1487887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0C3FBDF-2D16-4511-84C6-6780A9DA5E9E}"/>
              </a:ext>
            </a:extLst>
          </p:cNvPr>
          <p:cNvSpPr txBox="1"/>
          <p:nvPr/>
        </p:nvSpPr>
        <p:spPr>
          <a:xfrm flipH="1">
            <a:off x="24424697" y="7234349"/>
            <a:ext cx="96520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B</a:t>
            </a:r>
            <a:endParaRPr lang="ru-RU" sz="8000" b="1" dirty="0"/>
          </a:p>
        </p:txBody>
      </p:sp>
      <p:grpSp>
        <p:nvGrpSpPr>
          <p:cNvPr id="5" name="Группа 4">
            <a:extLst>
              <a:ext uri="{FF2B5EF4-FFF2-40B4-BE49-F238E27FC236}">
                <a16:creationId xmlns:a16="http://schemas.microsoft.com/office/drawing/2014/main" id="{7FD322E2-D233-4656-B5A6-E9DFE2BD6702}"/>
              </a:ext>
            </a:extLst>
          </p:cNvPr>
          <p:cNvGrpSpPr/>
          <p:nvPr/>
        </p:nvGrpSpPr>
        <p:grpSpPr>
          <a:xfrm>
            <a:off x="355498" y="7352332"/>
            <a:ext cx="24343989" cy="17622663"/>
            <a:chOff x="147317" y="-466498"/>
            <a:chExt cx="24343989" cy="17622663"/>
          </a:xfrm>
        </p:grpSpPr>
        <p:pic>
          <p:nvPicPr>
            <p:cNvPr id="4" name="Рисунок 3">
              <a:extLst>
                <a:ext uri="{FF2B5EF4-FFF2-40B4-BE49-F238E27FC236}">
                  <a16:creationId xmlns:a16="http://schemas.microsoft.com/office/drawing/2014/main" id="{D446439A-0878-4366-A8A8-0ACA495C50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33" t="2236" b="2626"/>
            <a:stretch/>
          </p:blipFill>
          <p:spPr>
            <a:xfrm>
              <a:off x="147317" y="1391809"/>
              <a:ext cx="23528650" cy="15764356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A8C6FB7-1EA9-45A7-AA2C-513F8C7D3D20}"/>
                </a:ext>
              </a:extLst>
            </p:cNvPr>
            <p:cNvSpPr txBox="1"/>
            <p:nvPr/>
          </p:nvSpPr>
          <p:spPr>
            <a:xfrm flipH="1">
              <a:off x="655320" y="-466498"/>
              <a:ext cx="965201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0" b="1" dirty="0"/>
                <a:t>A</a:t>
              </a:r>
              <a:endParaRPr lang="ru-RU" sz="8000" b="1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BCDC226-2462-4E35-8F35-4BC5510E6966}"/>
                </a:ext>
              </a:extLst>
            </p:cNvPr>
            <p:cNvSpPr txBox="1"/>
            <p:nvPr/>
          </p:nvSpPr>
          <p:spPr>
            <a:xfrm>
              <a:off x="2472261" y="859551"/>
              <a:ext cx="602826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BMDCs 1:1 live MCA205</a:t>
              </a:r>
              <a:endParaRPr lang="ru-RU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F1C028D-7ED1-4507-8B24-B8CDF827D48F}"/>
                </a:ext>
              </a:extLst>
            </p:cNvPr>
            <p:cNvSpPr txBox="1"/>
            <p:nvPr/>
          </p:nvSpPr>
          <p:spPr>
            <a:xfrm>
              <a:off x="2472261" y="8802363"/>
              <a:ext cx="602826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BMDCs 1:5 live MCA205</a:t>
              </a:r>
              <a:endParaRPr lang="ru-RU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B02CEE5-896D-419A-BD69-C9FC0359DD5E}"/>
                </a:ext>
              </a:extLst>
            </p:cNvPr>
            <p:cNvSpPr txBox="1"/>
            <p:nvPr/>
          </p:nvSpPr>
          <p:spPr>
            <a:xfrm>
              <a:off x="9973520" y="859551"/>
              <a:ext cx="666665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BMDCs 1:1 MCA205 + </a:t>
              </a:r>
              <a:r>
                <a:rPr lang="en-US" sz="4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z</a:t>
              </a:r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ru-RU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FFCB9E5-B37B-41E1-A785-1F27434467D4}"/>
                </a:ext>
              </a:extLst>
            </p:cNvPr>
            <p:cNvSpPr txBox="1"/>
            <p:nvPr/>
          </p:nvSpPr>
          <p:spPr>
            <a:xfrm>
              <a:off x="9973520" y="8802363"/>
              <a:ext cx="666665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BMDCs 1:5 MCA205 + </a:t>
              </a:r>
              <a:r>
                <a:rPr lang="en-US" sz="4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z</a:t>
              </a:r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ru-RU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5C6AC80-FE64-4828-B204-9974D06350A8}"/>
                </a:ext>
              </a:extLst>
            </p:cNvPr>
            <p:cNvSpPr txBox="1"/>
            <p:nvPr/>
          </p:nvSpPr>
          <p:spPr>
            <a:xfrm>
              <a:off x="17587587" y="8802363"/>
              <a:ext cx="690371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BMDCs 1:5 MCA205 + </a:t>
              </a:r>
              <a:r>
                <a:rPr lang="en-US" sz="4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z</a:t>
              </a:r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 III</a:t>
              </a:r>
              <a:endParaRPr lang="ru-RU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F6A8782-91EB-4E04-B147-9C8CFE72758D}"/>
                </a:ext>
              </a:extLst>
            </p:cNvPr>
            <p:cNvSpPr txBox="1"/>
            <p:nvPr/>
          </p:nvSpPr>
          <p:spPr>
            <a:xfrm>
              <a:off x="17587587" y="859551"/>
              <a:ext cx="690371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BMDCs 1:1 MCA205 + </a:t>
              </a:r>
              <a:r>
                <a:rPr lang="en-US" sz="4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z</a:t>
              </a:r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 III</a:t>
              </a:r>
              <a:endParaRPr lang="ru-RU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F5760401-D944-464C-B575-185E497E653D}"/>
              </a:ext>
            </a:extLst>
          </p:cNvPr>
          <p:cNvSpPr txBox="1"/>
          <p:nvPr/>
        </p:nvSpPr>
        <p:spPr>
          <a:xfrm flipH="1">
            <a:off x="24424697" y="37404751"/>
            <a:ext cx="919855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/>
              <a:t>Supplementary Figure 2.</a:t>
            </a:r>
            <a:endParaRPr lang="ru-RU" sz="6600" b="1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0A86B32-D9A0-9948-8804-EDD285BDEFE4}"/>
              </a:ext>
            </a:extLst>
          </p:cNvPr>
          <p:cNvSpPr/>
          <p:nvPr/>
        </p:nvSpPr>
        <p:spPr>
          <a:xfrm>
            <a:off x="0" y="777344"/>
            <a:ext cx="33623250" cy="29238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b="1" dirty="0"/>
              <a:t>Novel </a:t>
            </a:r>
            <a:r>
              <a:rPr lang="en-US" sz="4800" b="1" dirty="0" err="1"/>
              <a:t>porphyrazine</a:t>
            </a:r>
            <a:r>
              <a:rPr lang="en-US" sz="4800" b="1" dirty="0"/>
              <a:t>-based photodynamic anti-cancer therapy induces immunogenic cell death</a:t>
            </a:r>
          </a:p>
          <a:p>
            <a:pPr algn="ctr"/>
            <a:endParaRPr lang="en-US" sz="4000" dirty="0"/>
          </a:p>
          <a:p>
            <a:pPr algn="ctr"/>
            <a:r>
              <a:rPr lang="en-US" sz="4800" dirty="0"/>
              <a:t>Victoria D. </a:t>
            </a:r>
            <a:r>
              <a:rPr lang="en-US" sz="4800" dirty="0" err="1"/>
              <a:t>Turubanova</a:t>
            </a:r>
            <a:r>
              <a:rPr lang="en-US" sz="4800" dirty="0"/>
              <a:t>, Tatiana A. </a:t>
            </a:r>
            <a:r>
              <a:rPr lang="en-US" sz="4800" dirty="0" err="1"/>
              <a:t>Mishchenko</a:t>
            </a:r>
            <a:r>
              <a:rPr lang="en-US" sz="4800" dirty="0"/>
              <a:t>, Irina V. </a:t>
            </a:r>
            <a:r>
              <a:rPr lang="en-US" sz="4800" dirty="0" err="1"/>
              <a:t>Balalaeva</a:t>
            </a:r>
            <a:r>
              <a:rPr lang="en-US" sz="4800" dirty="0"/>
              <a:t>, </a:t>
            </a:r>
            <a:r>
              <a:rPr lang="en-US" sz="4800" dirty="0" err="1"/>
              <a:t>Iuliia</a:t>
            </a:r>
            <a:r>
              <a:rPr lang="en-US" sz="4800" dirty="0"/>
              <a:t> </a:t>
            </a:r>
            <a:r>
              <a:rPr lang="en-US" sz="4800" dirty="0" err="1"/>
              <a:t>Efimova</a:t>
            </a:r>
            <a:r>
              <a:rPr lang="en-US" sz="4800" dirty="0"/>
              <a:t>, Nina N. </a:t>
            </a:r>
            <a:r>
              <a:rPr lang="en-US" sz="4800" dirty="0" err="1"/>
              <a:t>Peskova</a:t>
            </a:r>
            <a:r>
              <a:rPr lang="en-US" sz="4800" dirty="0"/>
              <a:t>, Larisa G. </a:t>
            </a:r>
            <a:r>
              <a:rPr lang="en-US" sz="4800" dirty="0" err="1"/>
              <a:t>Klapshina</a:t>
            </a:r>
            <a:r>
              <a:rPr lang="en-US" sz="4800" dirty="0"/>
              <a:t>, Svetlana A. </a:t>
            </a:r>
            <a:r>
              <a:rPr lang="en-US" sz="4800" dirty="0" err="1"/>
              <a:t>Lermontova</a:t>
            </a:r>
            <a:r>
              <a:rPr lang="en-US" sz="4800" dirty="0"/>
              <a:t>, Claus </a:t>
            </a:r>
            <a:r>
              <a:rPr lang="en-US" sz="4800" dirty="0" err="1"/>
              <a:t>Bachert</a:t>
            </a:r>
            <a:r>
              <a:rPr lang="en-US" sz="4800" dirty="0"/>
              <a:t>, Olga Krysko, Maria V. </a:t>
            </a:r>
            <a:r>
              <a:rPr lang="en-US" sz="4800" dirty="0" err="1"/>
              <a:t>Vedunova</a:t>
            </a:r>
            <a:r>
              <a:rPr lang="en-US" sz="4800" dirty="0"/>
              <a:t>, Dmitri V. Krysko</a:t>
            </a:r>
          </a:p>
        </p:txBody>
      </p:sp>
    </p:spTree>
    <p:extLst>
      <p:ext uri="{BB962C8B-B14F-4D97-AF65-F5344CB8AC3E}">
        <p14:creationId xmlns:p14="http://schemas.microsoft.com/office/powerpoint/2010/main" val="9780343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2">
            <a:extLst>
              <a:ext uri="{FF2B5EF4-FFF2-40B4-BE49-F238E27FC236}">
                <a16:creationId xmlns:a16="http://schemas.microsoft.com/office/drawing/2014/main" id="{99EDC239-2DA6-403C-A92E-4E35B9493F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137" y="4274369"/>
            <a:ext cx="23245011" cy="3423837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A36FEC0-0BA2-4253-A0F6-DD0BF9CAD43D}"/>
              </a:ext>
            </a:extLst>
          </p:cNvPr>
          <p:cNvSpPr txBox="1"/>
          <p:nvPr/>
        </p:nvSpPr>
        <p:spPr>
          <a:xfrm flipH="1">
            <a:off x="24384000" y="37404751"/>
            <a:ext cx="92392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/>
              <a:t>Supplementary Figure 3.</a:t>
            </a:r>
            <a:endParaRPr lang="ru-RU" sz="66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98E321-855F-4E7C-8008-30380E66246E}"/>
              </a:ext>
            </a:extLst>
          </p:cNvPr>
          <p:cNvSpPr txBox="1"/>
          <p:nvPr/>
        </p:nvSpPr>
        <p:spPr>
          <a:xfrm>
            <a:off x="2810492" y="4059846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A</a:t>
            </a:r>
            <a:endParaRPr lang="ru-RU" sz="8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052DA2-46BF-462B-A995-689881C40828}"/>
              </a:ext>
            </a:extLst>
          </p:cNvPr>
          <p:cNvSpPr txBox="1"/>
          <p:nvPr/>
        </p:nvSpPr>
        <p:spPr>
          <a:xfrm>
            <a:off x="13038726" y="4059846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B</a:t>
            </a:r>
            <a:endParaRPr lang="ru-RU" sz="8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D7BD6A9-7660-40B2-A365-6CFA2866D561}"/>
              </a:ext>
            </a:extLst>
          </p:cNvPr>
          <p:cNvSpPr txBox="1"/>
          <p:nvPr/>
        </p:nvSpPr>
        <p:spPr>
          <a:xfrm>
            <a:off x="2806200" y="14853181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C</a:t>
            </a:r>
            <a:endParaRPr lang="ru-RU" sz="8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5079D7-40AD-47D0-B563-EC670C759879}"/>
              </a:ext>
            </a:extLst>
          </p:cNvPr>
          <p:cNvSpPr txBox="1"/>
          <p:nvPr/>
        </p:nvSpPr>
        <p:spPr>
          <a:xfrm>
            <a:off x="13038726" y="14853180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D</a:t>
            </a:r>
            <a:endParaRPr lang="ru-RU" sz="80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B3EB5D4-2F3D-4DE7-8A9C-06FFE0DFAD9C}"/>
              </a:ext>
            </a:extLst>
          </p:cNvPr>
          <p:cNvSpPr txBox="1"/>
          <p:nvPr/>
        </p:nvSpPr>
        <p:spPr>
          <a:xfrm>
            <a:off x="2806200" y="25646516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E</a:t>
            </a:r>
            <a:endParaRPr lang="ru-RU" sz="8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F9DBFF-DA40-487B-8887-5C9C3A517336}"/>
              </a:ext>
            </a:extLst>
          </p:cNvPr>
          <p:cNvSpPr txBox="1"/>
          <p:nvPr/>
        </p:nvSpPr>
        <p:spPr>
          <a:xfrm>
            <a:off x="13038726" y="25646516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F</a:t>
            </a:r>
            <a:endParaRPr lang="ru-RU" sz="8000" b="1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00CB09A-16AA-4A44-A558-8A0D450F798A}"/>
              </a:ext>
            </a:extLst>
          </p:cNvPr>
          <p:cNvSpPr/>
          <p:nvPr/>
        </p:nvSpPr>
        <p:spPr>
          <a:xfrm>
            <a:off x="0" y="777344"/>
            <a:ext cx="33623250" cy="29238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b="1" dirty="0"/>
              <a:t>Novel </a:t>
            </a:r>
            <a:r>
              <a:rPr lang="en-US" sz="4800" b="1" dirty="0" err="1"/>
              <a:t>porphyrazine</a:t>
            </a:r>
            <a:r>
              <a:rPr lang="en-US" sz="4800" b="1" dirty="0"/>
              <a:t>-based photodynamic anti-cancer therapy induces immunogenic cell death</a:t>
            </a:r>
          </a:p>
          <a:p>
            <a:pPr algn="ctr"/>
            <a:endParaRPr lang="en-US" sz="4000" dirty="0"/>
          </a:p>
          <a:p>
            <a:pPr algn="ctr"/>
            <a:r>
              <a:rPr lang="en-US" sz="4800" dirty="0"/>
              <a:t>Victoria D. </a:t>
            </a:r>
            <a:r>
              <a:rPr lang="en-US" sz="4800" dirty="0" err="1"/>
              <a:t>Turubanova</a:t>
            </a:r>
            <a:r>
              <a:rPr lang="en-US" sz="4800" dirty="0"/>
              <a:t>, Tatiana A. </a:t>
            </a:r>
            <a:r>
              <a:rPr lang="en-US" sz="4800" dirty="0" err="1"/>
              <a:t>Mishchenko</a:t>
            </a:r>
            <a:r>
              <a:rPr lang="en-US" sz="4800" dirty="0"/>
              <a:t>, Irina V. </a:t>
            </a:r>
            <a:r>
              <a:rPr lang="en-US" sz="4800" dirty="0" err="1"/>
              <a:t>Balalaeva</a:t>
            </a:r>
            <a:r>
              <a:rPr lang="en-US" sz="4800" dirty="0"/>
              <a:t>, </a:t>
            </a:r>
            <a:r>
              <a:rPr lang="en-US" sz="4800" dirty="0" err="1"/>
              <a:t>Iuliia</a:t>
            </a:r>
            <a:r>
              <a:rPr lang="en-US" sz="4800" dirty="0"/>
              <a:t> </a:t>
            </a:r>
            <a:r>
              <a:rPr lang="en-US" sz="4800" dirty="0" err="1"/>
              <a:t>Efimova</a:t>
            </a:r>
            <a:r>
              <a:rPr lang="en-US" sz="4800" dirty="0"/>
              <a:t>, Nina N. </a:t>
            </a:r>
            <a:r>
              <a:rPr lang="en-US" sz="4800" dirty="0" err="1"/>
              <a:t>Peskova</a:t>
            </a:r>
            <a:r>
              <a:rPr lang="en-US" sz="4800" dirty="0"/>
              <a:t>, Larisa G. </a:t>
            </a:r>
            <a:r>
              <a:rPr lang="en-US" sz="4800" dirty="0" err="1"/>
              <a:t>Klapshina</a:t>
            </a:r>
            <a:r>
              <a:rPr lang="en-US" sz="4800" dirty="0"/>
              <a:t>, Svetlana A. </a:t>
            </a:r>
            <a:r>
              <a:rPr lang="en-US" sz="4800" dirty="0" err="1"/>
              <a:t>Lermontova</a:t>
            </a:r>
            <a:r>
              <a:rPr lang="en-US" sz="4800" dirty="0"/>
              <a:t>, Claus </a:t>
            </a:r>
            <a:r>
              <a:rPr lang="en-US" sz="4800" dirty="0" err="1"/>
              <a:t>Bachert</a:t>
            </a:r>
            <a:r>
              <a:rPr lang="en-US" sz="4800" dirty="0"/>
              <a:t>, Olga Krysko, Maria V. </a:t>
            </a:r>
            <a:r>
              <a:rPr lang="en-US" sz="4800" dirty="0" err="1"/>
              <a:t>Vedunova</a:t>
            </a:r>
            <a:r>
              <a:rPr lang="en-US" sz="4800" dirty="0"/>
              <a:t>, Dmitri V. Krysko</a:t>
            </a:r>
          </a:p>
        </p:txBody>
      </p:sp>
    </p:spTree>
    <p:extLst>
      <p:ext uri="{BB962C8B-B14F-4D97-AF65-F5344CB8AC3E}">
        <p14:creationId xmlns:p14="http://schemas.microsoft.com/office/powerpoint/2010/main" val="16867010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Рисунок 11">
            <a:extLst>
              <a:ext uri="{FF2B5EF4-FFF2-40B4-BE49-F238E27FC236}">
                <a16:creationId xmlns:a16="http://schemas.microsoft.com/office/drawing/2014/main" id="{4193DB18-C641-487D-9BD6-82814A2AE0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010" y="4204231"/>
            <a:ext cx="23245011" cy="3423837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1B178D4-FD5E-48C0-A114-C5E42CFAEBD6}"/>
              </a:ext>
            </a:extLst>
          </p:cNvPr>
          <p:cNvSpPr txBox="1"/>
          <p:nvPr/>
        </p:nvSpPr>
        <p:spPr>
          <a:xfrm>
            <a:off x="2810492" y="4011727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A</a:t>
            </a:r>
            <a:endParaRPr lang="ru-RU" sz="80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A635E73-27A7-49B1-8E6B-D7B534E67F7B}"/>
              </a:ext>
            </a:extLst>
          </p:cNvPr>
          <p:cNvSpPr txBox="1"/>
          <p:nvPr/>
        </p:nvSpPr>
        <p:spPr>
          <a:xfrm>
            <a:off x="13038726" y="4011727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B</a:t>
            </a:r>
            <a:endParaRPr lang="ru-RU" sz="80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8AABBEA-3B0F-43A5-9C41-ED04502DC1D8}"/>
              </a:ext>
            </a:extLst>
          </p:cNvPr>
          <p:cNvSpPr txBox="1"/>
          <p:nvPr/>
        </p:nvSpPr>
        <p:spPr>
          <a:xfrm>
            <a:off x="2806200" y="14805062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C</a:t>
            </a:r>
            <a:endParaRPr lang="ru-RU" sz="8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4C01FA-6E2B-471D-B1E4-1994BD42E108}"/>
              </a:ext>
            </a:extLst>
          </p:cNvPr>
          <p:cNvSpPr txBox="1"/>
          <p:nvPr/>
        </p:nvSpPr>
        <p:spPr>
          <a:xfrm>
            <a:off x="13038726" y="14805061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D</a:t>
            </a:r>
            <a:endParaRPr lang="ru-RU" sz="80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2BB87F6-0378-42FC-A3D5-95891ACB4CD8}"/>
              </a:ext>
            </a:extLst>
          </p:cNvPr>
          <p:cNvSpPr txBox="1"/>
          <p:nvPr/>
        </p:nvSpPr>
        <p:spPr>
          <a:xfrm>
            <a:off x="2806200" y="25598397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E</a:t>
            </a:r>
            <a:endParaRPr lang="ru-RU" sz="8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CEEA010-F253-4340-B6E4-6C8F70037977}"/>
              </a:ext>
            </a:extLst>
          </p:cNvPr>
          <p:cNvSpPr txBox="1"/>
          <p:nvPr/>
        </p:nvSpPr>
        <p:spPr>
          <a:xfrm>
            <a:off x="13038726" y="25598397"/>
            <a:ext cx="1357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b="1" dirty="0"/>
              <a:t>F</a:t>
            </a:r>
            <a:endParaRPr lang="ru-RU" sz="8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4CB00D-6AFA-4D4B-8DBD-1BFFD554888D}"/>
              </a:ext>
            </a:extLst>
          </p:cNvPr>
          <p:cNvSpPr txBox="1"/>
          <p:nvPr/>
        </p:nvSpPr>
        <p:spPr>
          <a:xfrm flipH="1">
            <a:off x="24323040" y="37404751"/>
            <a:ext cx="930021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/>
              <a:t>Supplementary Figure </a:t>
            </a:r>
            <a:r>
              <a:rPr lang="ru-RU" sz="6600" b="1" dirty="0"/>
              <a:t>4</a:t>
            </a:r>
            <a:r>
              <a:rPr lang="en-US" sz="6600" b="1" dirty="0"/>
              <a:t>.</a:t>
            </a:r>
            <a:endParaRPr lang="ru-RU" sz="6600" b="1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A936113-6E16-7E45-9BE3-ECFCBB67831A}"/>
              </a:ext>
            </a:extLst>
          </p:cNvPr>
          <p:cNvSpPr/>
          <p:nvPr/>
        </p:nvSpPr>
        <p:spPr>
          <a:xfrm>
            <a:off x="0" y="777344"/>
            <a:ext cx="33623250" cy="29238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b="1" dirty="0"/>
              <a:t>Novel </a:t>
            </a:r>
            <a:r>
              <a:rPr lang="en-US" sz="4800" b="1" dirty="0" err="1"/>
              <a:t>porphyrazine</a:t>
            </a:r>
            <a:r>
              <a:rPr lang="en-US" sz="4800" b="1" dirty="0"/>
              <a:t>-based photodynamic anti-cancer therapy induces immunogenic cell death</a:t>
            </a:r>
          </a:p>
          <a:p>
            <a:pPr algn="ctr"/>
            <a:endParaRPr lang="en-US" sz="4000" dirty="0"/>
          </a:p>
          <a:p>
            <a:pPr algn="ctr"/>
            <a:r>
              <a:rPr lang="en-US" sz="4800" dirty="0"/>
              <a:t>Victoria D. </a:t>
            </a:r>
            <a:r>
              <a:rPr lang="en-US" sz="4800" dirty="0" err="1"/>
              <a:t>Turubanova</a:t>
            </a:r>
            <a:r>
              <a:rPr lang="en-US" sz="4800" dirty="0"/>
              <a:t>, Tatiana A. </a:t>
            </a:r>
            <a:r>
              <a:rPr lang="en-US" sz="4800" dirty="0" err="1"/>
              <a:t>Mishchenko</a:t>
            </a:r>
            <a:r>
              <a:rPr lang="en-US" sz="4800" dirty="0"/>
              <a:t>, Irina V. </a:t>
            </a:r>
            <a:r>
              <a:rPr lang="en-US" sz="4800" dirty="0" err="1"/>
              <a:t>Balalaeva</a:t>
            </a:r>
            <a:r>
              <a:rPr lang="en-US" sz="4800" dirty="0"/>
              <a:t>, </a:t>
            </a:r>
            <a:r>
              <a:rPr lang="en-US" sz="4800" dirty="0" err="1"/>
              <a:t>Iuliia</a:t>
            </a:r>
            <a:r>
              <a:rPr lang="en-US" sz="4800" dirty="0"/>
              <a:t> </a:t>
            </a:r>
            <a:r>
              <a:rPr lang="en-US" sz="4800" dirty="0" err="1"/>
              <a:t>Efimova</a:t>
            </a:r>
            <a:r>
              <a:rPr lang="en-US" sz="4800" dirty="0"/>
              <a:t>, Nina N. </a:t>
            </a:r>
            <a:r>
              <a:rPr lang="en-US" sz="4800" dirty="0" err="1"/>
              <a:t>Peskova</a:t>
            </a:r>
            <a:r>
              <a:rPr lang="en-US" sz="4800" dirty="0"/>
              <a:t>, Larisa G. </a:t>
            </a:r>
            <a:r>
              <a:rPr lang="en-US" sz="4800" dirty="0" err="1"/>
              <a:t>Klapshina</a:t>
            </a:r>
            <a:r>
              <a:rPr lang="en-US" sz="4800" dirty="0"/>
              <a:t>, Svetlana A. </a:t>
            </a:r>
            <a:r>
              <a:rPr lang="en-US" sz="4800" dirty="0" err="1"/>
              <a:t>Lermontova</a:t>
            </a:r>
            <a:r>
              <a:rPr lang="en-US" sz="4800" dirty="0"/>
              <a:t>, Claus </a:t>
            </a:r>
            <a:r>
              <a:rPr lang="en-US" sz="4800" dirty="0" err="1"/>
              <a:t>Bachert</a:t>
            </a:r>
            <a:r>
              <a:rPr lang="en-US" sz="4800" dirty="0"/>
              <a:t>, Olga Krysko, Maria V. </a:t>
            </a:r>
            <a:r>
              <a:rPr lang="en-US" sz="4800" dirty="0" err="1"/>
              <a:t>Vedunova</a:t>
            </a:r>
            <a:r>
              <a:rPr lang="en-US" sz="4800" dirty="0"/>
              <a:t>, Dmitri V. Krysko</a:t>
            </a:r>
          </a:p>
        </p:txBody>
      </p:sp>
    </p:spTree>
    <p:extLst>
      <p:ext uri="{BB962C8B-B14F-4D97-AF65-F5344CB8AC3E}">
        <p14:creationId xmlns:p14="http://schemas.microsoft.com/office/powerpoint/2010/main" val="73311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Рисунок 11">
            <a:extLst>
              <a:ext uri="{FF2B5EF4-FFF2-40B4-BE49-F238E27FC236}">
                <a16:creationId xmlns:a16="http://schemas.microsoft.com/office/drawing/2014/main" id="{33E06BDD-E305-4A65-B965-DD09ADD46C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4148" y="4685484"/>
            <a:ext cx="22319725" cy="3222739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1624BF5-25C5-45FB-8BAD-9CAEB596EF50}"/>
              </a:ext>
            </a:extLst>
          </p:cNvPr>
          <p:cNvSpPr txBox="1"/>
          <p:nvPr/>
        </p:nvSpPr>
        <p:spPr>
          <a:xfrm>
            <a:off x="2469979" y="4348602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A</a:t>
            </a:r>
            <a:endParaRPr lang="ru-RU" sz="9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026659-668B-4150-9CD9-C5727F9FA769}"/>
              </a:ext>
            </a:extLst>
          </p:cNvPr>
          <p:cNvSpPr txBox="1"/>
          <p:nvPr/>
        </p:nvSpPr>
        <p:spPr>
          <a:xfrm>
            <a:off x="14124571" y="4348602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B</a:t>
            </a:r>
            <a:endParaRPr lang="ru-RU" sz="96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EE02FB8-32D1-49E1-873B-2449250A8B99}"/>
              </a:ext>
            </a:extLst>
          </p:cNvPr>
          <p:cNvSpPr txBox="1"/>
          <p:nvPr/>
        </p:nvSpPr>
        <p:spPr>
          <a:xfrm>
            <a:off x="2478001" y="14703787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C</a:t>
            </a:r>
            <a:endParaRPr lang="ru-RU" sz="96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9170485-D622-493E-8EB9-8AB560A2B370}"/>
              </a:ext>
            </a:extLst>
          </p:cNvPr>
          <p:cNvSpPr txBox="1"/>
          <p:nvPr/>
        </p:nvSpPr>
        <p:spPr>
          <a:xfrm>
            <a:off x="14132593" y="14703787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D</a:t>
            </a:r>
            <a:endParaRPr lang="ru-RU" sz="96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1F8A50-663E-423B-B38D-A6ED727ECF6A}"/>
              </a:ext>
            </a:extLst>
          </p:cNvPr>
          <p:cNvSpPr txBox="1"/>
          <p:nvPr/>
        </p:nvSpPr>
        <p:spPr>
          <a:xfrm>
            <a:off x="2534149" y="25058970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E</a:t>
            </a:r>
            <a:endParaRPr lang="ru-RU" sz="96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A4A766-439A-4C48-A754-701729958A80}"/>
              </a:ext>
            </a:extLst>
          </p:cNvPr>
          <p:cNvSpPr txBox="1"/>
          <p:nvPr/>
        </p:nvSpPr>
        <p:spPr>
          <a:xfrm>
            <a:off x="14188741" y="25058970"/>
            <a:ext cx="13571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b="1" dirty="0"/>
              <a:t>F</a:t>
            </a:r>
            <a:endParaRPr lang="ru-RU" sz="96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DD11E0F-1A70-4A0E-947B-218C20B2015A}"/>
              </a:ext>
            </a:extLst>
          </p:cNvPr>
          <p:cNvSpPr txBox="1"/>
          <p:nvPr/>
        </p:nvSpPr>
        <p:spPr>
          <a:xfrm flipH="1">
            <a:off x="24384000" y="37404751"/>
            <a:ext cx="92392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/>
              <a:t>Supplementary Figure 5.</a:t>
            </a:r>
            <a:endParaRPr lang="ru-RU" sz="6600" b="1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248B8E9-5A8D-FD41-98EB-3264E2AA6452}"/>
              </a:ext>
            </a:extLst>
          </p:cNvPr>
          <p:cNvSpPr/>
          <p:nvPr/>
        </p:nvSpPr>
        <p:spPr>
          <a:xfrm>
            <a:off x="0" y="777344"/>
            <a:ext cx="33623250" cy="29238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b="1" dirty="0"/>
              <a:t>Novel </a:t>
            </a:r>
            <a:r>
              <a:rPr lang="en-US" sz="4800" b="1" dirty="0" err="1"/>
              <a:t>porphyrazine</a:t>
            </a:r>
            <a:r>
              <a:rPr lang="en-US" sz="4800" b="1" dirty="0"/>
              <a:t>-based photodynamic anti-cancer therapy induces immunogenic cell death</a:t>
            </a:r>
          </a:p>
          <a:p>
            <a:pPr algn="ctr"/>
            <a:endParaRPr lang="en-US" sz="4000" dirty="0"/>
          </a:p>
          <a:p>
            <a:pPr algn="ctr"/>
            <a:r>
              <a:rPr lang="en-US" sz="4800" dirty="0"/>
              <a:t>Victoria D. </a:t>
            </a:r>
            <a:r>
              <a:rPr lang="en-US" sz="4800" dirty="0" err="1"/>
              <a:t>Turubanova</a:t>
            </a:r>
            <a:r>
              <a:rPr lang="en-US" sz="4800" dirty="0"/>
              <a:t>, Tatiana A. </a:t>
            </a:r>
            <a:r>
              <a:rPr lang="en-US" sz="4800" dirty="0" err="1"/>
              <a:t>Mishchenko</a:t>
            </a:r>
            <a:r>
              <a:rPr lang="en-US" sz="4800" dirty="0"/>
              <a:t>, Irina V. </a:t>
            </a:r>
            <a:r>
              <a:rPr lang="en-US" sz="4800" dirty="0" err="1"/>
              <a:t>Balalaeva</a:t>
            </a:r>
            <a:r>
              <a:rPr lang="en-US" sz="4800" dirty="0"/>
              <a:t>, </a:t>
            </a:r>
            <a:r>
              <a:rPr lang="en-US" sz="4800" dirty="0" err="1"/>
              <a:t>Iuliia</a:t>
            </a:r>
            <a:r>
              <a:rPr lang="en-US" sz="4800" dirty="0"/>
              <a:t> </a:t>
            </a:r>
            <a:r>
              <a:rPr lang="en-US" sz="4800" dirty="0" err="1"/>
              <a:t>Efimova</a:t>
            </a:r>
            <a:r>
              <a:rPr lang="en-US" sz="4800" dirty="0"/>
              <a:t>, Nina N. </a:t>
            </a:r>
            <a:r>
              <a:rPr lang="en-US" sz="4800" dirty="0" err="1"/>
              <a:t>Peskova</a:t>
            </a:r>
            <a:r>
              <a:rPr lang="en-US" sz="4800" dirty="0"/>
              <a:t>, Larisa G. </a:t>
            </a:r>
            <a:r>
              <a:rPr lang="en-US" sz="4800" dirty="0" err="1"/>
              <a:t>Klapshina</a:t>
            </a:r>
            <a:r>
              <a:rPr lang="en-US" sz="4800" dirty="0"/>
              <a:t>, Svetlana A. </a:t>
            </a:r>
            <a:r>
              <a:rPr lang="en-US" sz="4800" dirty="0" err="1"/>
              <a:t>Lermontova</a:t>
            </a:r>
            <a:r>
              <a:rPr lang="en-US" sz="4800" dirty="0"/>
              <a:t>, Claus </a:t>
            </a:r>
            <a:r>
              <a:rPr lang="en-US" sz="4800" dirty="0" err="1"/>
              <a:t>Bachert</a:t>
            </a:r>
            <a:r>
              <a:rPr lang="en-US" sz="4800" dirty="0"/>
              <a:t>, Olga Krysko, Maria V. </a:t>
            </a:r>
            <a:r>
              <a:rPr lang="en-US" sz="4800" dirty="0" err="1"/>
              <a:t>Vedunova</a:t>
            </a:r>
            <a:r>
              <a:rPr lang="en-US" sz="4800" dirty="0"/>
              <a:t>, Dmitri V. Krysko</a:t>
            </a:r>
          </a:p>
        </p:txBody>
      </p:sp>
    </p:spTree>
    <p:extLst>
      <p:ext uri="{BB962C8B-B14F-4D97-AF65-F5344CB8AC3E}">
        <p14:creationId xmlns:p14="http://schemas.microsoft.com/office/powerpoint/2010/main" val="56479686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8</TotalTime>
  <Words>364</Words>
  <Application>Microsoft Macintosh PowerPoint</Application>
  <PresentationFormat>Custom</PresentationFormat>
  <Paragraphs>53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Тема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Turubanova Viktoria</dc:creator>
  <cp:lastModifiedBy>Dmitri Krysko</cp:lastModifiedBy>
  <cp:revision>107</cp:revision>
  <cp:lastPrinted>2021-02-01T09:37:26Z</cp:lastPrinted>
  <dcterms:created xsi:type="dcterms:W3CDTF">2020-04-02T07:51:36Z</dcterms:created>
  <dcterms:modified xsi:type="dcterms:W3CDTF">2021-02-01T10:22:55Z</dcterms:modified>
</cp:coreProperties>
</file>